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8.png" ContentType="image/png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F7F910-78DC-4C63-B833-3056F304F79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BD1A49-2B8D-496C-9FAA-21B7922989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8B5BD3-181D-4DE6-B698-5EAB3478C92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8F049D-3E63-4AC1-9015-22857A1B641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F4B404-014F-40B6-B308-27A51C2FB1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AADD36-5E3E-476F-A5CD-142DBCE7ED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D03CB6-2795-49C0-B3E0-BA0BC6EBAD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B65B83-589A-4DEB-8E78-6471E34CF9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0A59C0-5085-46DC-8ED0-5A9442E6FA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D8756B-9811-4933-9A4B-5AA8AA1ABA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AFCABE-A930-4085-9D27-D48A1B0675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C9F201-5458-4769-AD4B-FE7A05C3B3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166C2C4-EB8E-41EF-8DD6-3006A8C7AEE3}" type="slidenum"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-492120" y="7697880"/>
            <a:ext cx="787716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Supporting Figure 1: Acute leptin and IL-6 treatments on pY-STAT3 phosphorylation in HuH7 cells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Times New Roman"/>
              </a:rPr>
              <a:t>A) HuH7 cells were transfected with pcDNA3-LepRb and empty pcDNA3 vectors for 36 hours. Cells were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Times New Roman"/>
              </a:rPr>
              <a:t>then serum starved for 16 hours before leptin (100ng/mL) during the indicated periods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Representative Western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Blots and quantitative analysis of pSTAT3(Y705) and total STAT3. B) HuH7 cells were serum starved and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treated with 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</a:rPr>
              <a:t>or IL-6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(10 ng/ml)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</a:rPr>
              <a:t> for 5 or 15 minutes. 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Representative Western Blots and quantificaton pSTAT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(Y705) and total STAT3,in IL-6-treated HuH-7 cells. Data are means ± SEM (n=3/group). *p&lt;0.05 compared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to respective control cells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Rectangle 59"/>
          <p:cNvSpPr/>
          <p:nvPr/>
        </p:nvSpPr>
        <p:spPr>
          <a:xfrm>
            <a:off x="2160" y="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Rectangle 60"/>
          <p:cNvSpPr/>
          <p:nvPr/>
        </p:nvSpPr>
        <p:spPr>
          <a:xfrm>
            <a:off x="1800" y="491004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4" name="Picture 3" descr="C:\Users\machauvin\Desktop\STAT3 L1 -12.jpg"/>
          <p:cNvPicPr/>
          <p:nvPr/>
        </p:nvPicPr>
        <p:blipFill>
          <a:blip r:embed="rId1"/>
          <a:srcRect l="8504" t="41651" r="18087" b="43975"/>
          <a:stretch/>
        </p:blipFill>
        <p:spPr>
          <a:xfrm>
            <a:off x="533520" y="1285920"/>
            <a:ext cx="2666880" cy="390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5" name="Picture 19" descr="C:\Users\machauvin\Desktop\Tot 13 à 24.jpg"/>
          <p:cNvPicPr/>
          <p:nvPr/>
        </p:nvPicPr>
        <p:blipFill>
          <a:blip r:embed="rId2"/>
          <a:srcRect l="5352" t="31026" r="4311" b="54729"/>
          <a:stretch/>
        </p:blipFill>
        <p:spPr>
          <a:xfrm>
            <a:off x="3906720" y="1314360"/>
            <a:ext cx="2646360" cy="3114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6" name="Picture 2" descr="C:\Users\machauvin\Desktop\p 1 à 12.jpg"/>
          <p:cNvPicPr/>
          <p:nvPr/>
        </p:nvPicPr>
        <p:blipFill>
          <a:blip r:embed="rId3"/>
          <a:srcRect l="16028" t="39565" r="10753" b="47798"/>
          <a:stretch/>
        </p:blipFill>
        <p:spPr>
          <a:xfrm>
            <a:off x="533520" y="733320"/>
            <a:ext cx="2660400" cy="343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7" name="Picture 3" descr="C:\Users\machauvin\Desktop\13 à 24.jpg"/>
          <p:cNvPicPr/>
          <p:nvPr/>
        </p:nvPicPr>
        <p:blipFill>
          <a:blip r:embed="rId4"/>
          <a:srcRect l="5352" t="33404" r="4311" b="53620"/>
          <a:stretch/>
        </p:blipFill>
        <p:spPr>
          <a:xfrm>
            <a:off x="3906720" y="746280"/>
            <a:ext cx="2646360" cy="284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8" name="Text Box 96"/>
          <p:cNvSpPr/>
          <p:nvPr/>
        </p:nvSpPr>
        <p:spPr>
          <a:xfrm>
            <a:off x="0" y="380880"/>
            <a:ext cx="327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Leptin:   -    -    -   +    +    +   -    -    -    +    +   +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Rectangle 97"/>
          <p:cNvSpPr/>
          <p:nvPr/>
        </p:nvSpPr>
        <p:spPr>
          <a:xfrm>
            <a:off x="762480" y="152280"/>
            <a:ext cx="921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Empty vector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Rectangle 114"/>
          <p:cNvSpPr/>
          <p:nvPr/>
        </p:nvSpPr>
        <p:spPr>
          <a:xfrm>
            <a:off x="2209320" y="152280"/>
            <a:ext cx="488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LepRb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Text Box 115"/>
          <p:cNvSpPr/>
          <p:nvPr/>
        </p:nvSpPr>
        <p:spPr>
          <a:xfrm>
            <a:off x="3201120" y="720720"/>
            <a:ext cx="741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pSTAT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(Y705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Text Box 116"/>
          <p:cNvSpPr/>
          <p:nvPr/>
        </p:nvSpPr>
        <p:spPr>
          <a:xfrm>
            <a:off x="3201480" y="133020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TAT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609480" y="380880"/>
            <a:ext cx="1219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1905120" y="380880"/>
            <a:ext cx="1218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Text Box 96"/>
          <p:cNvSpPr/>
          <p:nvPr/>
        </p:nvSpPr>
        <p:spPr>
          <a:xfrm>
            <a:off x="3387600" y="380880"/>
            <a:ext cx="327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Leptin:   -    -    -   +    +    +   -    -    -    +    +   +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Rectangle 97"/>
          <p:cNvSpPr/>
          <p:nvPr/>
        </p:nvSpPr>
        <p:spPr>
          <a:xfrm>
            <a:off x="4150080" y="152280"/>
            <a:ext cx="921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Empty vector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Rectangle 114"/>
          <p:cNvSpPr/>
          <p:nvPr/>
        </p:nvSpPr>
        <p:spPr>
          <a:xfrm>
            <a:off x="5596920" y="152280"/>
            <a:ext cx="488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LepRb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3997440" y="380880"/>
            <a:ext cx="1218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5292720" y="380880"/>
            <a:ext cx="1219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Text Box 116"/>
          <p:cNvSpPr/>
          <p:nvPr/>
        </p:nvSpPr>
        <p:spPr>
          <a:xfrm>
            <a:off x="1145880" y="1828800"/>
            <a:ext cx="165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5 minutes of treatmen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Text Box 116"/>
          <p:cNvSpPr/>
          <p:nvPr/>
        </p:nvSpPr>
        <p:spPr>
          <a:xfrm>
            <a:off x="4422600" y="1828800"/>
            <a:ext cx="173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15 minutes of treatmen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2" name="Picture 2" descr="C:\Users\machauvin\Desktop\STAT3 IL.jpg"/>
          <p:cNvPicPr/>
          <p:nvPr/>
        </p:nvPicPr>
        <p:blipFill>
          <a:blip r:embed="rId5"/>
          <a:srcRect l="10634" t="40202" r="10711" b="48405"/>
          <a:stretch/>
        </p:blipFill>
        <p:spPr>
          <a:xfrm>
            <a:off x="752400" y="6794640"/>
            <a:ext cx="2633760" cy="284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3" name="Picture 32" descr="C:\Users\machauvin\Desktop\pY-STAT3.jpg"/>
          <p:cNvPicPr/>
          <p:nvPr/>
        </p:nvPicPr>
        <p:blipFill>
          <a:blip r:embed="rId6"/>
          <a:srcRect l="14316" t="36454" r="7704" b="52753"/>
          <a:stretch/>
        </p:blipFill>
        <p:spPr>
          <a:xfrm>
            <a:off x="776160" y="6264360"/>
            <a:ext cx="2576520" cy="2667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4" name="Text Box 96"/>
          <p:cNvSpPr/>
          <p:nvPr/>
        </p:nvSpPr>
        <p:spPr>
          <a:xfrm>
            <a:off x="330120" y="5832360"/>
            <a:ext cx="327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IL-6 :   -    -    -   +    +    +   -    -    -    +    +   +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Rectangle 97"/>
          <p:cNvSpPr/>
          <p:nvPr/>
        </p:nvSpPr>
        <p:spPr>
          <a:xfrm>
            <a:off x="1110600" y="5603760"/>
            <a:ext cx="669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 minute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Rectangle 114"/>
          <p:cNvSpPr/>
          <p:nvPr/>
        </p:nvSpPr>
        <p:spPr>
          <a:xfrm>
            <a:off x="2372760" y="5603760"/>
            <a:ext cx="7459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5 minute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828720" y="5832360"/>
            <a:ext cx="1219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2124000" y="5832360"/>
            <a:ext cx="1219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Text Box 115"/>
          <p:cNvSpPr/>
          <p:nvPr/>
        </p:nvSpPr>
        <p:spPr>
          <a:xfrm>
            <a:off x="76680" y="6194520"/>
            <a:ext cx="741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pSTAT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(Y705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Text Box 116"/>
          <p:cNvSpPr/>
          <p:nvPr/>
        </p:nvSpPr>
        <p:spPr>
          <a:xfrm>
            <a:off x="77400" y="680400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TAT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1981080" y="4276800"/>
            <a:ext cx="293760" cy="439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1978200" y="4273560"/>
            <a:ext cx="293400" cy="4395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2274840" y="3983040"/>
            <a:ext cx="293760" cy="7333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2271600" y="3992400"/>
            <a:ext cx="293760" cy="7207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 flipV="1">
            <a:off x="2124000" y="4249800"/>
            <a:ext cx="180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2103480" y="4249800"/>
            <a:ext cx="4140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 flipV="1">
            <a:off x="2417760" y="3898440"/>
            <a:ext cx="1440" cy="81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2398680" y="3898800"/>
            <a:ext cx="4140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2576520" y="4095720"/>
            <a:ext cx="293760" cy="6145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2573280" y="4092480"/>
            <a:ext cx="293760" cy="6145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2870280" y="3875040"/>
            <a:ext cx="293760" cy="83520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2867040" y="3871800"/>
            <a:ext cx="293760" cy="83520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 flipV="1">
            <a:off x="2719440" y="3987360"/>
            <a:ext cx="1440" cy="104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2698920" y="3987720"/>
            <a:ext cx="4104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 flipV="1">
            <a:off x="3013200" y="3675240"/>
            <a:ext cx="1440" cy="1965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2994120" y="3675240"/>
            <a:ext cx="4104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3597120" y="4130640"/>
            <a:ext cx="295560" cy="579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3594240" y="4127400"/>
            <a:ext cx="295200" cy="57960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3892680" y="3851280"/>
            <a:ext cx="293400" cy="8589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3889440" y="3848040"/>
            <a:ext cx="293760" cy="8589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 flipV="1">
            <a:off x="3741840" y="3895560"/>
            <a:ext cx="1440" cy="231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3720960" y="3889440"/>
            <a:ext cx="4140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 flipV="1">
            <a:off x="4035600" y="3696840"/>
            <a:ext cx="1440" cy="1508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4016520" y="3697200"/>
            <a:ext cx="3960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95" name=""/>
          <p:cNvGrpSpPr/>
          <p:nvPr/>
        </p:nvGrpSpPr>
        <p:grpSpPr>
          <a:xfrm>
            <a:off x="4183200" y="2556000"/>
            <a:ext cx="591840" cy="2160360"/>
            <a:chOff x="4183200" y="2556000"/>
            <a:chExt cx="591840" cy="2160360"/>
          </a:xfrm>
        </p:grpSpPr>
        <p:sp>
          <p:nvSpPr>
            <p:cNvPr id="96" name=""/>
            <p:cNvSpPr/>
            <p:nvPr/>
          </p:nvSpPr>
          <p:spPr>
            <a:xfrm>
              <a:off x="4186080" y="4160880"/>
              <a:ext cx="295560" cy="55548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4183200" y="4157640"/>
              <a:ext cx="295200" cy="5554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4481640" y="3057480"/>
              <a:ext cx="293400" cy="16588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4478400" y="3054240"/>
              <a:ext cx="293760" cy="16588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"/>
            <p:cNvSpPr/>
            <p:nvPr/>
          </p:nvSpPr>
          <p:spPr>
            <a:xfrm flipV="1">
              <a:off x="4330800" y="4005000"/>
              <a:ext cx="1440" cy="152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4309920" y="4005360"/>
              <a:ext cx="414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"/>
            <p:cNvSpPr/>
            <p:nvPr/>
          </p:nvSpPr>
          <p:spPr>
            <a:xfrm flipV="1">
              <a:off x="4624560" y="2556000"/>
              <a:ext cx="1440" cy="498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4605480" y="2556000"/>
              <a:ext cx="4104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04" name=""/>
          <p:cNvSpPr/>
          <p:nvPr/>
        </p:nvSpPr>
        <p:spPr>
          <a:xfrm>
            <a:off x="1760400" y="2397240"/>
            <a:ext cx="1800" cy="231912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1744560" y="4716360"/>
            <a:ext cx="1584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1744560" y="4484520"/>
            <a:ext cx="1584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1744560" y="4253040"/>
            <a:ext cx="1584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1744560" y="4021200"/>
            <a:ext cx="1584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1744560" y="3789360"/>
            <a:ext cx="1584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1744560" y="3557520"/>
            <a:ext cx="1584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1744560" y="3324240"/>
            <a:ext cx="1584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1744560" y="3092400"/>
            <a:ext cx="1584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1744560" y="2860560"/>
            <a:ext cx="1584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1744560" y="2629080"/>
            <a:ext cx="1584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1744560" y="2397240"/>
            <a:ext cx="1584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>
            <a:off x="1760400" y="4716360"/>
            <a:ext cx="323532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 flipV="1">
            <a:off x="1760400" y="4716000"/>
            <a:ext cx="1800" cy="176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1613880" y="4668840"/>
            <a:ext cx="58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1527120" y="4437000"/>
            <a:ext cx="20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0.02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>
            <a:off x="1527120" y="4205160"/>
            <a:ext cx="20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0.04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>
            <a:off x="1527120" y="3973680"/>
            <a:ext cx="20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0.06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>
            <a:off x="1527120" y="3741840"/>
            <a:ext cx="20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0.08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1560960" y="351000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0.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>
            <a:off x="1527120" y="3276720"/>
            <a:ext cx="20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0.12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>
            <a:off x="1527120" y="3043080"/>
            <a:ext cx="20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0.14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1527120" y="2811600"/>
            <a:ext cx="20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0.16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>
            <a:off x="1527120" y="2579760"/>
            <a:ext cx="20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0.18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>
            <a:off x="1560960" y="234792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0.2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>
            <a:off x="2306880" y="4761000"/>
            <a:ext cx="524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5 minute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>
            <a:off x="3902040" y="4761000"/>
            <a:ext cx="588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15 minute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 rot="16200000">
            <a:off x="855720" y="3474360"/>
            <a:ext cx="983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pYSTAT3/STAT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>
            <a:off x="4457880" y="6251400"/>
            <a:ext cx="299880" cy="920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>
            <a:off x="4456080" y="6249960"/>
            <a:ext cx="300240" cy="9190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"/>
          <p:cNvSpPr/>
          <p:nvPr/>
        </p:nvSpPr>
        <p:spPr>
          <a:xfrm>
            <a:off x="5508720" y="6251400"/>
            <a:ext cx="299880" cy="920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>
            <a:off x="5506920" y="6249960"/>
            <a:ext cx="300240" cy="9190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"/>
          <p:cNvSpPr/>
          <p:nvPr/>
        </p:nvSpPr>
        <p:spPr>
          <a:xfrm>
            <a:off x="4757760" y="5649840"/>
            <a:ext cx="299880" cy="15224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"/>
          <p:cNvSpPr/>
          <p:nvPr/>
        </p:nvSpPr>
        <p:spPr>
          <a:xfrm>
            <a:off x="4756320" y="5646600"/>
            <a:ext cx="299880" cy="152244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5808600" y="5888160"/>
            <a:ext cx="300240" cy="12841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>
            <a:off x="5807160" y="5884920"/>
            <a:ext cx="299880" cy="128412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 flipV="1">
            <a:off x="4605480" y="6124680"/>
            <a:ext cx="1440" cy="125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/>
          <p:nvPr/>
        </p:nvSpPr>
        <p:spPr>
          <a:xfrm>
            <a:off x="4594320" y="6124680"/>
            <a:ext cx="237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"/>
          <p:cNvSpPr/>
          <p:nvPr/>
        </p:nvSpPr>
        <p:spPr>
          <a:xfrm flipV="1">
            <a:off x="5656320" y="6175080"/>
            <a:ext cx="1440" cy="745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"/>
          <p:cNvSpPr/>
          <p:nvPr/>
        </p:nvSpPr>
        <p:spPr>
          <a:xfrm>
            <a:off x="5645160" y="6175440"/>
            <a:ext cx="237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"/>
          <p:cNvSpPr/>
          <p:nvPr/>
        </p:nvSpPr>
        <p:spPr>
          <a:xfrm flipV="1">
            <a:off x="4905360" y="5571720"/>
            <a:ext cx="1440" cy="745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"/>
          <p:cNvSpPr/>
          <p:nvPr/>
        </p:nvSpPr>
        <p:spPr>
          <a:xfrm>
            <a:off x="4894200" y="5572080"/>
            <a:ext cx="237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"/>
          <p:cNvSpPr/>
          <p:nvPr/>
        </p:nvSpPr>
        <p:spPr>
          <a:xfrm flipV="1">
            <a:off x="5956200" y="5807160"/>
            <a:ext cx="1800" cy="777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"/>
          <p:cNvSpPr/>
          <p:nvPr/>
        </p:nvSpPr>
        <p:spPr>
          <a:xfrm>
            <a:off x="5945040" y="5807160"/>
            <a:ext cx="241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"/>
          <p:cNvSpPr/>
          <p:nvPr/>
        </p:nvSpPr>
        <p:spPr>
          <a:xfrm>
            <a:off x="4232160" y="5330880"/>
            <a:ext cx="1800" cy="18414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"/>
          <p:cNvSpPr/>
          <p:nvPr/>
        </p:nvSpPr>
        <p:spPr>
          <a:xfrm>
            <a:off x="4221000" y="7172280"/>
            <a:ext cx="1116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"/>
          <p:cNvSpPr/>
          <p:nvPr/>
        </p:nvSpPr>
        <p:spPr>
          <a:xfrm>
            <a:off x="4221000" y="6988320"/>
            <a:ext cx="1116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"/>
          <p:cNvSpPr/>
          <p:nvPr/>
        </p:nvSpPr>
        <p:spPr>
          <a:xfrm>
            <a:off x="4221000" y="6804000"/>
            <a:ext cx="1116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>
            <a:off x="4221000" y="6620040"/>
            <a:ext cx="1116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>
            <a:off x="4221000" y="6435720"/>
            <a:ext cx="1116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>
            <a:off x="4221000" y="6251400"/>
            <a:ext cx="1116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"/>
          <p:cNvSpPr/>
          <p:nvPr/>
        </p:nvSpPr>
        <p:spPr>
          <a:xfrm>
            <a:off x="4221000" y="6067440"/>
            <a:ext cx="1116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"/>
          <p:cNvSpPr/>
          <p:nvPr/>
        </p:nvSpPr>
        <p:spPr>
          <a:xfrm>
            <a:off x="4221000" y="5883120"/>
            <a:ext cx="1116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"/>
          <p:cNvSpPr/>
          <p:nvPr/>
        </p:nvSpPr>
        <p:spPr>
          <a:xfrm>
            <a:off x="4221000" y="5699160"/>
            <a:ext cx="1116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"/>
          <p:cNvSpPr/>
          <p:nvPr/>
        </p:nvSpPr>
        <p:spPr>
          <a:xfrm>
            <a:off x="4221000" y="5514840"/>
            <a:ext cx="1116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"/>
          <p:cNvSpPr/>
          <p:nvPr/>
        </p:nvSpPr>
        <p:spPr>
          <a:xfrm>
            <a:off x="4221000" y="5330880"/>
            <a:ext cx="1116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"/>
          <p:cNvSpPr/>
          <p:nvPr/>
        </p:nvSpPr>
        <p:spPr>
          <a:xfrm>
            <a:off x="4232160" y="7172280"/>
            <a:ext cx="210204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"/>
          <p:cNvSpPr/>
          <p:nvPr/>
        </p:nvSpPr>
        <p:spPr>
          <a:xfrm flipV="1">
            <a:off x="4232160" y="7171920"/>
            <a:ext cx="1800" cy="1908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"/>
          <p:cNvSpPr/>
          <p:nvPr/>
        </p:nvSpPr>
        <p:spPr>
          <a:xfrm>
            <a:off x="4018320" y="712152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0.0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"/>
          <p:cNvSpPr/>
          <p:nvPr/>
        </p:nvSpPr>
        <p:spPr>
          <a:xfrm>
            <a:off x="4018320" y="693900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0.2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"/>
          <p:cNvSpPr/>
          <p:nvPr/>
        </p:nvSpPr>
        <p:spPr>
          <a:xfrm>
            <a:off x="4018320" y="675324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0.4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"/>
          <p:cNvSpPr/>
          <p:nvPr/>
        </p:nvSpPr>
        <p:spPr>
          <a:xfrm>
            <a:off x="4018320" y="656892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0.6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"/>
          <p:cNvSpPr/>
          <p:nvPr/>
        </p:nvSpPr>
        <p:spPr>
          <a:xfrm>
            <a:off x="4018320" y="638496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0.8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"/>
          <p:cNvSpPr/>
          <p:nvPr/>
        </p:nvSpPr>
        <p:spPr>
          <a:xfrm>
            <a:off x="4018320" y="620244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1.0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"/>
          <p:cNvSpPr/>
          <p:nvPr/>
        </p:nvSpPr>
        <p:spPr>
          <a:xfrm>
            <a:off x="4018320" y="601668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1.2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9" name=""/>
          <p:cNvSpPr/>
          <p:nvPr/>
        </p:nvSpPr>
        <p:spPr>
          <a:xfrm>
            <a:off x="4018320" y="583236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1.4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"/>
          <p:cNvSpPr/>
          <p:nvPr/>
        </p:nvSpPr>
        <p:spPr>
          <a:xfrm>
            <a:off x="4018320" y="564984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1.6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"/>
          <p:cNvSpPr/>
          <p:nvPr/>
        </p:nvSpPr>
        <p:spPr>
          <a:xfrm>
            <a:off x="4018320" y="546408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1.8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"/>
          <p:cNvSpPr/>
          <p:nvPr/>
        </p:nvSpPr>
        <p:spPr>
          <a:xfrm>
            <a:off x="4018320" y="528012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2.0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"/>
          <p:cNvSpPr/>
          <p:nvPr/>
        </p:nvSpPr>
        <p:spPr>
          <a:xfrm rot="16200000">
            <a:off x="3387960" y="6186240"/>
            <a:ext cx="1018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pY/STAT3/STAT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Rectangle 267"/>
          <p:cNvSpPr/>
          <p:nvPr/>
        </p:nvSpPr>
        <p:spPr>
          <a:xfrm>
            <a:off x="6089760" y="5207040"/>
            <a:ext cx="126720" cy="11412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5" name="Rectangle 268"/>
          <p:cNvSpPr/>
          <p:nvPr/>
        </p:nvSpPr>
        <p:spPr>
          <a:xfrm>
            <a:off x="6314760" y="5170320"/>
            <a:ext cx="186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Co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Rectangle 270"/>
          <p:cNvSpPr/>
          <p:nvPr/>
        </p:nvSpPr>
        <p:spPr>
          <a:xfrm>
            <a:off x="6089760" y="5415120"/>
            <a:ext cx="126720" cy="11412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7" name="Rectangle 271"/>
          <p:cNvSpPr/>
          <p:nvPr/>
        </p:nvSpPr>
        <p:spPr>
          <a:xfrm>
            <a:off x="6314400" y="5378400"/>
            <a:ext cx="2887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IL-6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Rectangle 97"/>
          <p:cNvSpPr/>
          <p:nvPr/>
        </p:nvSpPr>
        <p:spPr>
          <a:xfrm>
            <a:off x="4425840" y="7267680"/>
            <a:ext cx="556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5 minute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Rectangle 114"/>
          <p:cNvSpPr/>
          <p:nvPr/>
        </p:nvSpPr>
        <p:spPr>
          <a:xfrm>
            <a:off x="5535720" y="7267680"/>
            <a:ext cx="621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15 minute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Text Box 40"/>
          <p:cNvSpPr/>
          <p:nvPr/>
        </p:nvSpPr>
        <p:spPr>
          <a:xfrm>
            <a:off x="4751280" y="522432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Text Box 40"/>
          <p:cNvSpPr/>
          <p:nvPr/>
        </p:nvSpPr>
        <p:spPr>
          <a:xfrm>
            <a:off x="5830920" y="544032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Rectangle 267"/>
          <p:cNvSpPr/>
          <p:nvPr/>
        </p:nvSpPr>
        <p:spPr>
          <a:xfrm>
            <a:off x="5276880" y="2768760"/>
            <a:ext cx="127080" cy="11412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3" name="Rectangle 268"/>
          <p:cNvSpPr/>
          <p:nvPr/>
        </p:nvSpPr>
        <p:spPr>
          <a:xfrm>
            <a:off x="5502240" y="2732040"/>
            <a:ext cx="794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pcDNA3-Co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Rectangle 270"/>
          <p:cNvSpPr/>
          <p:nvPr/>
        </p:nvSpPr>
        <p:spPr>
          <a:xfrm>
            <a:off x="5276880" y="2976480"/>
            <a:ext cx="127080" cy="1144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Rectangle 271"/>
          <p:cNvSpPr/>
          <p:nvPr/>
        </p:nvSpPr>
        <p:spPr>
          <a:xfrm>
            <a:off x="5502240" y="2940120"/>
            <a:ext cx="1041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pcDNA3-Leptin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6" name="Rectangle 267"/>
          <p:cNvSpPr/>
          <p:nvPr/>
        </p:nvSpPr>
        <p:spPr>
          <a:xfrm>
            <a:off x="5276880" y="3187800"/>
            <a:ext cx="127080" cy="114120"/>
          </a:xfrm>
          <a:prstGeom prst="rect">
            <a:avLst/>
          </a:prstGeom>
          <a:solidFill>
            <a:srgbClr val="c0c0c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7" name="Rectangle 268"/>
          <p:cNvSpPr/>
          <p:nvPr/>
        </p:nvSpPr>
        <p:spPr>
          <a:xfrm>
            <a:off x="5501880" y="3151080"/>
            <a:ext cx="686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LepRb-Co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Rectangle 270"/>
          <p:cNvSpPr/>
          <p:nvPr/>
        </p:nvSpPr>
        <p:spPr>
          <a:xfrm>
            <a:off x="5276880" y="3395520"/>
            <a:ext cx="127080" cy="114480"/>
          </a:xfrm>
          <a:prstGeom prst="rect">
            <a:avLst/>
          </a:prstGeom>
          <a:solidFill>
            <a:srgbClr val="80808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9" name="Rectangle 271"/>
          <p:cNvSpPr/>
          <p:nvPr/>
        </p:nvSpPr>
        <p:spPr>
          <a:xfrm>
            <a:off x="5501520" y="3359160"/>
            <a:ext cx="933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LepRb-Leptin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"/>
          <p:cNvSpPr/>
          <p:nvPr/>
        </p:nvSpPr>
        <p:spPr>
          <a:xfrm>
            <a:off x="2036880" y="2928960"/>
            <a:ext cx="315720" cy="2793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1" name=""/>
          <p:cNvSpPr/>
          <p:nvPr/>
        </p:nvSpPr>
        <p:spPr>
          <a:xfrm>
            <a:off x="3332160" y="2928960"/>
            <a:ext cx="317520" cy="2793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2" name=""/>
          <p:cNvSpPr/>
          <p:nvPr/>
        </p:nvSpPr>
        <p:spPr>
          <a:xfrm>
            <a:off x="4754520" y="2928960"/>
            <a:ext cx="317520" cy="2793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3" name=""/>
          <p:cNvSpPr/>
          <p:nvPr/>
        </p:nvSpPr>
        <p:spPr>
          <a:xfrm>
            <a:off x="2352600" y="1268280"/>
            <a:ext cx="306360" cy="19400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4" name=""/>
          <p:cNvSpPr/>
          <p:nvPr/>
        </p:nvSpPr>
        <p:spPr>
          <a:xfrm>
            <a:off x="3649680" y="2954160"/>
            <a:ext cx="306360" cy="2541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5" name=""/>
          <p:cNvSpPr/>
          <p:nvPr/>
        </p:nvSpPr>
        <p:spPr>
          <a:xfrm>
            <a:off x="5072040" y="2954160"/>
            <a:ext cx="306360" cy="2541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6" name=""/>
          <p:cNvSpPr/>
          <p:nvPr/>
        </p:nvSpPr>
        <p:spPr>
          <a:xfrm flipV="1">
            <a:off x="2195640" y="2903040"/>
            <a:ext cx="0" cy="25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7" name=""/>
          <p:cNvSpPr/>
          <p:nvPr/>
        </p:nvSpPr>
        <p:spPr>
          <a:xfrm>
            <a:off x="2163600" y="2903400"/>
            <a:ext cx="73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8" name=""/>
          <p:cNvSpPr/>
          <p:nvPr/>
        </p:nvSpPr>
        <p:spPr>
          <a:xfrm flipV="1">
            <a:off x="3490920" y="2877840"/>
            <a:ext cx="0" cy="50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9" name=""/>
          <p:cNvSpPr/>
          <p:nvPr/>
        </p:nvSpPr>
        <p:spPr>
          <a:xfrm>
            <a:off x="3459240" y="2878200"/>
            <a:ext cx="73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0" name=""/>
          <p:cNvSpPr/>
          <p:nvPr/>
        </p:nvSpPr>
        <p:spPr>
          <a:xfrm flipV="1">
            <a:off x="4913280" y="2903040"/>
            <a:ext cx="0" cy="25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1" name=""/>
          <p:cNvSpPr/>
          <p:nvPr/>
        </p:nvSpPr>
        <p:spPr>
          <a:xfrm>
            <a:off x="4881600" y="2903400"/>
            <a:ext cx="74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2" name=""/>
          <p:cNvSpPr/>
          <p:nvPr/>
        </p:nvSpPr>
        <p:spPr>
          <a:xfrm flipV="1">
            <a:off x="2502000" y="1053720"/>
            <a:ext cx="0" cy="214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3" name=""/>
          <p:cNvSpPr/>
          <p:nvPr/>
        </p:nvSpPr>
        <p:spPr>
          <a:xfrm>
            <a:off x="2470320" y="1054080"/>
            <a:ext cx="72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4" name=""/>
          <p:cNvSpPr/>
          <p:nvPr/>
        </p:nvSpPr>
        <p:spPr>
          <a:xfrm flipV="1">
            <a:off x="3797280" y="2928960"/>
            <a:ext cx="0" cy="25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5" name=""/>
          <p:cNvSpPr/>
          <p:nvPr/>
        </p:nvSpPr>
        <p:spPr>
          <a:xfrm>
            <a:off x="3765600" y="2928960"/>
            <a:ext cx="73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"/>
          <p:cNvSpPr/>
          <p:nvPr/>
        </p:nvSpPr>
        <p:spPr>
          <a:xfrm flipV="1">
            <a:off x="5219640" y="2928960"/>
            <a:ext cx="0" cy="25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"/>
          <p:cNvSpPr/>
          <p:nvPr/>
        </p:nvSpPr>
        <p:spPr>
          <a:xfrm>
            <a:off x="5187960" y="2928960"/>
            <a:ext cx="745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"/>
          <p:cNvSpPr/>
          <p:nvPr/>
        </p:nvSpPr>
        <p:spPr>
          <a:xfrm>
            <a:off x="1452600" y="939960"/>
            <a:ext cx="0" cy="22683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9" name=""/>
          <p:cNvSpPr/>
          <p:nvPr/>
        </p:nvSpPr>
        <p:spPr>
          <a:xfrm>
            <a:off x="1398600" y="3208320"/>
            <a:ext cx="54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0" name=""/>
          <p:cNvSpPr/>
          <p:nvPr/>
        </p:nvSpPr>
        <p:spPr>
          <a:xfrm>
            <a:off x="1398600" y="2928960"/>
            <a:ext cx="54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1" name=""/>
          <p:cNvSpPr/>
          <p:nvPr/>
        </p:nvSpPr>
        <p:spPr>
          <a:xfrm>
            <a:off x="1398600" y="2638440"/>
            <a:ext cx="54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2" name=""/>
          <p:cNvSpPr/>
          <p:nvPr/>
        </p:nvSpPr>
        <p:spPr>
          <a:xfrm>
            <a:off x="1398600" y="2359080"/>
            <a:ext cx="54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3" name=""/>
          <p:cNvSpPr/>
          <p:nvPr/>
        </p:nvSpPr>
        <p:spPr>
          <a:xfrm>
            <a:off x="1398600" y="2079720"/>
            <a:ext cx="54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4" name=""/>
          <p:cNvSpPr/>
          <p:nvPr/>
        </p:nvSpPr>
        <p:spPr>
          <a:xfrm>
            <a:off x="1398600" y="1789200"/>
            <a:ext cx="54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5" name=""/>
          <p:cNvSpPr/>
          <p:nvPr/>
        </p:nvSpPr>
        <p:spPr>
          <a:xfrm>
            <a:off x="1398600" y="1509840"/>
            <a:ext cx="54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6" name=""/>
          <p:cNvSpPr/>
          <p:nvPr/>
        </p:nvSpPr>
        <p:spPr>
          <a:xfrm>
            <a:off x="1398600" y="1219320"/>
            <a:ext cx="54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7" name=""/>
          <p:cNvSpPr/>
          <p:nvPr/>
        </p:nvSpPr>
        <p:spPr>
          <a:xfrm>
            <a:off x="1398600" y="939960"/>
            <a:ext cx="540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8" name=""/>
          <p:cNvSpPr/>
          <p:nvPr/>
        </p:nvSpPr>
        <p:spPr>
          <a:xfrm>
            <a:off x="1452600" y="3208320"/>
            <a:ext cx="44784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9" name=""/>
          <p:cNvSpPr/>
          <p:nvPr/>
        </p:nvSpPr>
        <p:spPr>
          <a:xfrm flipV="1">
            <a:off x="1452600" y="3208320"/>
            <a:ext cx="0" cy="38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0" name=""/>
          <p:cNvSpPr/>
          <p:nvPr/>
        </p:nvSpPr>
        <p:spPr>
          <a:xfrm>
            <a:off x="1239480" y="310680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1" name=""/>
          <p:cNvSpPr/>
          <p:nvPr/>
        </p:nvSpPr>
        <p:spPr>
          <a:xfrm>
            <a:off x="1239480" y="282888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2" name=""/>
          <p:cNvSpPr/>
          <p:nvPr/>
        </p:nvSpPr>
        <p:spPr>
          <a:xfrm>
            <a:off x="1239480" y="253692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3" name=""/>
          <p:cNvSpPr/>
          <p:nvPr/>
        </p:nvSpPr>
        <p:spPr>
          <a:xfrm>
            <a:off x="1239480" y="225756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4" name=""/>
          <p:cNvSpPr/>
          <p:nvPr/>
        </p:nvSpPr>
        <p:spPr>
          <a:xfrm>
            <a:off x="1239480" y="197964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5" name=""/>
          <p:cNvSpPr/>
          <p:nvPr/>
        </p:nvSpPr>
        <p:spPr>
          <a:xfrm>
            <a:off x="1239480" y="168768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6" name=""/>
          <p:cNvSpPr/>
          <p:nvPr/>
        </p:nvSpPr>
        <p:spPr>
          <a:xfrm>
            <a:off x="1239480" y="140796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7" name=""/>
          <p:cNvSpPr/>
          <p:nvPr/>
        </p:nvSpPr>
        <p:spPr>
          <a:xfrm>
            <a:off x="1239480" y="111744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8" name=""/>
          <p:cNvSpPr/>
          <p:nvPr/>
        </p:nvSpPr>
        <p:spPr>
          <a:xfrm>
            <a:off x="1239480" y="83808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9" name=""/>
          <p:cNvSpPr/>
          <p:nvPr/>
        </p:nvSpPr>
        <p:spPr>
          <a:xfrm>
            <a:off x="2166840" y="3340080"/>
            <a:ext cx="355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Liver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0" name=""/>
          <p:cNvSpPr/>
          <p:nvPr/>
        </p:nvSpPr>
        <p:spPr>
          <a:xfrm>
            <a:off x="3504600" y="3322800"/>
            <a:ext cx="365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ep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1" name=""/>
          <p:cNvSpPr/>
          <p:nvPr/>
        </p:nvSpPr>
        <p:spPr>
          <a:xfrm>
            <a:off x="4570920" y="3359160"/>
            <a:ext cx="959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Hypothalamu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2" name=""/>
          <p:cNvSpPr/>
          <p:nvPr/>
        </p:nvSpPr>
        <p:spPr>
          <a:xfrm rot="16200000">
            <a:off x="-85320" y="1915920"/>
            <a:ext cx="1666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FTO/TBP mRNA (a.u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3" name="Text Box 48"/>
          <p:cNvSpPr/>
          <p:nvPr/>
        </p:nvSpPr>
        <p:spPr>
          <a:xfrm>
            <a:off x="2363760" y="6858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4" name=""/>
          <p:cNvSpPr/>
          <p:nvPr/>
        </p:nvSpPr>
        <p:spPr>
          <a:xfrm>
            <a:off x="159840" y="4227480"/>
            <a:ext cx="663336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Supporting Figure 2: Validation of the specific overexpression of FTO in liver of infected mice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Times New Roman"/>
              </a:rPr>
              <a:t>Mice were infected with adenovirus encoding either FTO or GFP (as control), by reorbital injections,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Times New Roman"/>
              </a:rPr>
              <a:t>for 10 days. FTO mRNA levels were measured by real-time RT-PCR and normalized by TBP, in liver,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Times New Roman"/>
              </a:rPr>
              <a:t>epididymal adipose tissue (epAT) and hypothlamus of infected mice. FTO was overexpressed specificall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Times New Roman"/>
              </a:rPr>
              <a:t>in liver of infected mice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35" name="Group 287"/>
          <p:cNvGrpSpPr/>
          <p:nvPr/>
        </p:nvGrpSpPr>
        <p:grpSpPr>
          <a:xfrm>
            <a:off x="4800600" y="838080"/>
            <a:ext cx="759600" cy="452880"/>
            <a:chOff x="4800600" y="838080"/>
            <a:chExt cx="759600" cy="452880"/>
          </a:xfrm>
        </p:grpSpPr>
        <p:sp>
          <p:nvSpPr>
            <p:cNvPr id="236" name="Rectangle 397"/>
            <p:cNvSpPr/>
            <p:nvPr/>
          </p:nvSpPr>
          <p:spPr>
            <a:xfrm>
              <a:off x="4800600" y="1131840"/>
              <a:ext cx="103320" cy="10800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7" name="Rectangle 394"/>
            <p:cNvSpPr/>
            <p:nvPr/>
          </p:nvSpPr>
          <p:spPr>
            <a:xfrm>
              <a:off x="5000040" y="1108080"/>
              <a:ext cx="560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Ad-FTO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8" name="Rectangle 395"/>
            <p:cNvSpPr/>
            <p:nvPr/>
          </p:nvSpPr>
          <p:spPr>
            <a:xfrm>
              <a:off x="4802040" y="871560"/>
              <a:ext cx="103320" cy="109440"/>
            </a:xfrm>
            <a:prstGeom prst="rect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9" name="Rectangle 396"/>
            <p:cNvSpPr/>
            <p:nvPr/>
          </p:nvSpPr>
          <p:spPr>
            <a:xfrm>
              <a:off x="4976640" y="838080"/>
              <a:ext cx="550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Ad-GFP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"/>
          <p:cNvSpPr/>
          <p:nvPr/>
        </p:nvSpPr>
        <p:spPr>
          <a:xfrm>
            <a:off x="-473400" y="7697880"/>
            <a:ext cx="784800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Supporting Figure 3: Effect of leptin on pY-STAT3 phosphorylation and G6P expression in rat primary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hepatocytes. 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</a:rPr>
              <a:t>Primary hepatocytes were isolated from rat liver and</a:t>
            </a: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</a:rPr>
              <a:t>treated for 3 hours with leptin</a:t>
            </a: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</a:rPr>
              <a:t>(100ng/mL)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A) Representative Western Blots and quantitative analysis of pSTAT3(Y705) and total STAT3, in rat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primary hepatocytes treated or not with leptin. B) mRNA levels of G6P in rat primary hepatocytes treated or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not with leptin. Data are means ± SEM (n=3/group). *p&lt;0.05 compared to untreated hepatocytes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241" name="" descr=""/>
          <p:cNvPicPr/>
          <p:nvPr/>
        </p:nvPicPr>
        <p:blipFill>
          <a:blip r:embed="rId1"/>
          <a:srcRect l="21183" t="37026" r="23430" b="52669"/>
          <a:stretch/>
        </p:blipFill>
        <p:spPr>
          <a:xfrm>
            <a:off x="1405080" y="1757520"/>
            <a:ext cx="1863720" cy="2584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242" name="" descr=""/>
          <p:cNvPicPr/>
          <p:nvPr/>
        </p:nvPicPr>
        <p:blipFill>
          <a:blip r:embed="rId2"/>
          <a:srcRect l="18113" t="19245" r="26415" b="69891"/>
          <a:stretch/>
        </p:blipFill>
        <p:spPr>
          <a:xfrm>
            <a:off x="1403280" y="2276640"/>
            <a:ext cx="1866960" cy="2728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43" name="Text Box 115"/>
          <p:cNvSpPr/>
          <p:nvPr/>
        </p:nvSpPr>
        <p:spPr>
          <a:xfrm>
            <a:off x="483120" y="1660680"/>
            <a:ext cx="741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pSTAT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(Y705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4" name="Text Box 116"/>
          <p:cNvSpPr/>
          <p:nvPr/>
        </p:nvSpPr>
        <p:spPr>
          <a:xfrm>
            <a:off x="483840" y="227016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TAT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5" name=""/>
          <p:cNvSpPr/>
          <p:nvPr/>
        </p:nvSpPr>
        <p:spPr>
          <a:xfrm>
            <a:off x="1409760" y="1600200"/>
            <a:ext cx="888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6" name=""/>
          <p:cNvSpPr/>
          <p:nvPr/>
        </p:nvSpPr>
        <p:spPr>
          <a:xfrm>
            <a:off x="2362320" y="1600200"/>
            <a:ext cx="888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7" name="Rectangle 97"/>
          <p:cNvSpPr/>
          <p:nvPr/>
        </p:nvSpPr>
        <p:spPr>
          <a:xfrm>
            <a:off x="1695240" y="1260360"/>
            <a:ext cx="2246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Co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8" name="Rectangle 114"/>
          <p:cNvSpPr/>
          <p:nvPr/>
        </p:nvSpPr>
        <p:spPr>
          <a:xfrm>
            <a:off x="2525040" y="1260360"/>
            <a:ext cx="4716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Leptin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49" name=""/>
          <p:cNvGrpSpPr/>
          <p:nvPr/>
        </p:nvGrpSpPr>
        <p:grpSpPr>
          <a:xfrm>
            <a:off x="3649680" y="865080"/>
            <a:ext cx="2909520" cy="2618280"/>
            <a:chOff x="3649680" y="865080"/>
            <a:chExt cx="2909520" cy="2618280"/>
          </a:xfrm>
        </p:grpSpPr>
        <p:sp>
          <p:nvSpPr>
            <p:cNvPr id="250" name=""/>
            <p:cNvSpPr/>
            <p:nvPr/>
          </p:nvSpPr>
          <p:spPr>
            <a:xfrm>
              <a:off x="4469400" y="1924560"/>
              <a:ext cx="491760" cy="1323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4467960" y="1921680"/>
              <a:ext cx="491400" cy="1321920"/>
            </a:xfrm>
            <a:prstGeom prst="rect">
              <a:avLst/>
            </a:prstGeom>
            <a:noFill/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5698800" y="1346040"/>
              <a:ext cx="490680" cy="19018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5697360" y="1341720"/>
              <a:ext cx="490320" cy="1901880"/>
            </a:xfrm>
            <a:prstGeom prst="rect">
              <a:avLst/>
            </a:prstGeom>
            <a:noFill/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4" name=""/>
            <p:cNvSpPr/>
            <p:nvPr/>
          </p:nvSpPr>
          <p:spPr>
            <a:xfrm flipV="1">
              <a:off x="4713120" y="1756080"/>
              <a:ext cx="1080" cy="1652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4701600" y="1756440"/>
              <a:ext cx="24480" cy="1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6" name=""/>
            <p:cNvSpPr/>
            <p:nvPr/>
          </p:nvSpPr>
          <p:spPr>
            <a:xfrm flipV="1">
              <a:off x="5942520" y="1276920"/>
              <a:ext cx="1080" cy="64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5931000" y="1276920"/>
              <a:ext cx="24480" cy="10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4102200" y="931680"/>
              <a:ext cx="1440" cy="2316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4090680" y="3248280"/>
              <a:ext cx="1116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4090680" y="2917800"/>
              <a:ext cx="1116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4090680" y="2585880"/>
              <a:ext cx="1116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4090680" y="2255040"/>
              <a:ext cx="111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4090680" y="1924560"/>
              <a:ext cx="1116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4090680" y="1594080"/>
              <a:ext cx="111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4090680" y="1262160"/>
              <a:ext cx="1116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4090680" y="931680"/>
              <a:ext cx="111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4102200" y="3248280"/>
              <a:ext cx="245700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8" name=""/>
            <p:cNvSpPr/>
            <p:nvPr/>
          </p:nvSpPr>
          <p:spPr>
            <a:xfrm flipV="1">
              <a:off x="4102200" y="3248280"/>
              <a:ext cx="1440" cy="201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3913200" y="3180240"/>
              <a:ext cx="16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3913200" y="2849400"/>
              <a:ext cx="16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3913200" y="2517480"/>
              <a:ext cx="16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3913200" y="2187000"/>
              <a:ext cx="16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3913200" y="1857960"/>
              <a:ext cx="16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3913200" y="1527480"/>
              <a:ext cx="16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.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3913200" y="1195560"/>
              <a:ext cx="16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.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3913200" y="865080"/>
              <a:ext cx="16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.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4692600" y="3300480"/>
              <a:ext cx="186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Co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5749200" y="3300480"/>
              <a:ext cx="433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Leptin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9" name=""/>
            <p:cNvSpPr/>
            <p:nvPr/>
          </p:nvSpPr>
          <p:spPr>
            <a:xfrm rot="16200000">
              <a:off x="3121200" y="1845720"/>
              <a:ext cx="1239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pY-STAT3/STAT3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80" name="Rectangle 59"/>
          <p:cNvSpPr/>
          <p:nvPr/>
        </p:nvSpPr>
        <p:spPr>
          <a:xfrm>
            <a:off x="0" y="0"/>
            <a:ext cx="5317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1" name="Rectangle 60"/>
          <p:cNvSpPr/>
          <p:nvPr/>
        </p:nvSpPr>
        <p:spPr>
          <a:xfrm>
            <a:off x="1800" y="389412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2" name="Text Box 40"/>
          <p:cNvSpPr/>
          <p:nvPr/>
        </p:nvSpPr>
        <p:spPr>
          <a:xfrm>
            <a:off x="5805360" y="97632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3" name=""/>
          <p:cNvSpPr/>
          <p:nvPr/>
        </p:nvSpPr>
        <p:spPr>
          <a:xfrm>
            <a:off x="2781360" y="4925880"/>
            <a:ext cx="563400" cy="1952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4" name=""/>
          <p:cNvSpPr/>
          <p:nvPr/>
        </p:nvSpPr>
        <p:spPr>
          <a:xfrm>
            <a:off x="2778120" y="4923000"/>
            <a:ext cx="563400" cy="1950840"/>
          </a:xfrm>
          <a:prstGeom prst="rect">
            <a:avLst/>
          </a:prstGeom>
          <a:noFill/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5" name=""/>
          <p:cNvSpPr/>
          <p:nvPr/>
        </p:nvSpPr>
        <p:spPr>
          <a:xfrm>
            <a:off x="4191120" y="5510160"/>
            <a:ext cx="563400" cy="13683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6" name=""/>
          <p:cNvSpPr/>
          <p:nvPr/>
        </p:nvSpPr>
        <p:spPr>
          <a:xfrm>
            <a:off x="4187880" y="5506920"/>
            <a:ext cx="563400" cy="1366920"/>
          </a:xfrm>
          <a:prstGeom prst="rect">
            <a:avLst/>
          </a:prstGeom>
          <a:noFill/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7" name=""/>
          <p:cNvSpPr/>
          <p:nvPr/>
        </p:nvSpPr>
        <p:spPr>
          <a:xfrm flipV="1">
            <a:off x="3060720" y="4684680"/>
            <a:ext cx="1440" cy="2383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8" name=""/>
          <p:cNvSpPr/>
          <p:nvPr/>
        </p:nvSpPr>
        <p:spPr>
          <a:xfrm>
            <a:off x="3044880" y="4684680"/>
            <a:ext cx="30240" cy="1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9" name=""/>
          <p:cNvSpPr/>
          <p:nvPr/>
        </p:nvSpPr>
        <p:spPr>
          <a:xfrm flipV="1">
            <a:off x="4468680" y="5308200"/>
            <a:ext cx="1800" cy="1983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0" name=""/>
          <p:cNvSpPr/>
          <p:nvPr/>
        </p:nvSpPr>
        <p:spPr>
          <a:xfrm>
            <a:off x="4454640" y="5308560"/>
            <a:ext cx="29880" cy="1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1" name=""/>
          <p:cNvSpPr/>
          <p:nvPr/>
        </p:nvSpPr>
        <p:spPr>
          <a:xfrm>
            <a:off x="2357280" y="4489560"/>
            <a:ext cx="1800" cy="238896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2" name=""/>
          <p:cNvSpPr/>
          <p:nvPr/>
        </p:nvSpPr>
        <p:spPr>
          <a:xfrm>
            <a:off x="2344680" y="6878520"/>
            <a:ext cx="1260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3" name=""/>
          <p:cNvSpPr/>
          <p:nvPr/>
        </p:nvSpPr>
        <p:spPr>
          <a:xfrm>
            <a:off x="2344680" y="6611760"/>
            <a:ext cx="1260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4" name=""/>
          <p:cNvSpPr/>
          <p:nvPr/>
        </p:nvSpPr>
        <p:spPr>
          <a:xfrm>
            <a:off x="2344680" y="6346800"/>
            <a:ext cx="1260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5" name=""/>
          <p:cNvSpPr/>
          <p:nvPr/>
        </p:nvSpPr>
        <p:spPr>
          <a:xfrm>
            <a:off x="2344680" y="6081840"/>
            <a:ext cx="1260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6" name=""/>
          <p:cNvSpPr/>
          <p:nvPr/>
        </p:nvSpPr>
        <p:spPr>
          <a:xfrm>
            <a:off x="2344680" y="5816520"/>
            <a:ext cx="1260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7" name=""/>
          <p:cNvSpPr/>
          <p:nvPr/>
        </p:nvSpPr>
        <p:spPr>
          <a:xfrm>
            <a:off x="2344680" y="5549760"/>
            <a:ext cx="1260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8" name=""/>
          <p:cNvSpPr/>
          <p:nvPr/>
        </p:nvSpPr>
        <p:spPr>
          <a:xfrm>
            <a:off x="2344680" y="5286240"/>
            <a:ext cx="1260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9" name=""/>
          <p:cNvSpPr/>
          <p:nvPr/>
        </p:nvSpPr>
        <p:spPr>
          <a:xfrm>
            <a:off x="2344680" y="5019840"/>
            <a:ext cx="1260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0" name=""/>
          <p:cNvSpPr/>
          <p:nvPr/>
        </p:nvSpPr>
        <p:spPr>
          <a:xfrm>
            <a:off x="2344680" y="4756320"/>
            <a:ext cx="1260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1" name=""/>
          <p:cNvSpPr/>
          <p:nvPr/>
        </p:nvSpPr>
        <p:spPr>
          <a:xfrm>
            <a:off x="2344680" y="4489560"/>
            <a:ext cx="1260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2" name=""/>
          <p:cNvSpPr/>
          <p:nvPr/>
        </p:nvSpPr>
        <p:spPr>
          <a:xfrm>
            <a:off x="2357280" y="6878520"/>
            <a:ext cx="281952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3" name=""/>
          <p:cNvSpPr/>
          <p:nvPr/>
        </p:nvSpPr>
        <p:spPr>
          <a:xfrm flipV="1">
            <a:off x="2357280" y="6878520"/>
            <a:ext cx="1800" cy="2376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4" name=""/>
          <p:cNvSpPr/>
          <p:nvPr/>
        </p:nvSpPr>
        <p:spPr>
          <a:xfrm>
            <a:off x="2062800" y="682776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5" name=""/>
          <p:cNvSpPr/>
          <p:nvPr/>
        </p:nvSpPr>
        <p:spPr>
          <a:xfrm>
            <a:off x="2062800" y="656100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0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6" name=""/>
          <p:cNvSpPr/>
          <p:nvPr/>
        </p:nvSpPr>
        <p:spPr>
          <a:xfrm>
            <a:off x="2062800" y="629748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0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7" name=""/>
          <p:cNvSpPr/>
          <p:nvPr/>
        </p:nvSpPr>
        <p:spPr>
          <a:xfrm>
            <a:off x="2062800" y="603108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0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8" name=""/>
          <p:cNvSpPr/>
          <p:nvPr/>
        </p:nvSpPr>
        <p:spPr>
          <a:xfrm>
            <a:off x="2062800" y="576756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0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9" name=""/>
          <p:cNvSpPr/>
          <p:nvPr/>
        </p:nvSpPr>
        <p:spPr>
          <a:xfrm>
            <a:off x="2062800" y="550080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1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0" name=""/>
          <p:cNvSpPr/>
          <p:nvPr/>
        </p:nvSpPr>
        <p:spPr>
          <a:xfrm>
            <a:off x="2062800" y="523548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1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1" name=""/>
          <p:cNvSpPr/>
          <p:nvPr/>
        </p:nvSpPr>
        <p:spPr>
          <a:xfrm>
            <a:off x="2062800" y="497052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1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2" name=""/>
          <p:cNvSpPr/>
          <p:nvPr/>
        </p:nvSpPr>
        <p:spPr>
          <a:xfrm>
            <a:off x="2062800" y="470520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1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3" name=""/>
          <p:cNvSpPr/>
          <p:nvPr/>
        </p:nvSpPr>
        <p:spPr>
          <a:xfrm>
            <a:off x="2062800" y="4438800"/>
            <a:ext cx="224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1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4" name=""/>
          <p:cNvSpPr/>
          <p:nvPr/>
        </p:nvSpPr>
        <p:spPr>
          <a:xfrm>
            <a:off x="2960280" y="6940440"/>
            <a:ext cx="186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Co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5" name=""/>
          <p:cNvSpPr/>
          <p:nvPr/>
        </p:nvSpPr>
        <p:spPr>
          <a:xfrm>
            <a:off x="4242600" y="6940440"/>
            <a:ext cx="4334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Leptin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6" name=""/>
          <p:cNvSpPr/>
          <p:nvPr/>
        </p:nvSpPr>
        <p:spPr>
          <a:xfrm rot="16200000">
            <a:off x="1051200" y="5574960"/>
            <a:ext cx="15156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G6P/TBP mRNA level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7" name="Text Box 40"/>
          <p:cNvSpPr/>
          <p:nvPr/>
        </p:nvSpPr>
        <p:spPr>
          <a:xfrm>
            <a:off x="4332240" y="48880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26T09:17:21Z</dcterms:created>
  <dc:creator>Jennifer Rieusset</dc:creator>
  <dc:description/>
  <dc:language>en-US</dc:language>
  <cp:lastModifiedBy>Jennifer Rieusset</cp:lastModifiedBy>
  <dcterms:modified xsi:type="dcterms:W3CDTF">2013-12-24T10:03:04Z</dcterms:modified>
  <cp:revision>14</cp:revision>
  <dc:subject/>
  <dc:title>Présentation PowerPoint</dc:title>
</cp:coreProperties>
</file>